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91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735889-2EA8-8722-0E50-314177453677}" name="森村洋行" initials="森村洋行" userId="S::morimura.hiroyuki@aist.go.jp::ed211b07-d528-444b-bd35-06dc1e2a91a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82155"/>
    <a:srgbClr val="DDCE76"/>
    <a:srgbClr val="0070C0"/>
    <a:srgbClr val="4F9136"/>
    <a:srgbClr val="AA4399"/>
    <a:srgbClr val="CC6577"/>
    <a:srgbClr val="E8E6E6"/>
    <a:srgbClr val="9EBCF5"/>
    <a:srgbClr val="322288"/>
    <a:srgbClr val="92D0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97495"/>
  </p:normalViewPr>
  <p:slideViewPr>
    <p:cSldViewPr snapToGrid="0">
      <p:cViewPr>
        <p:scale>
          <a:sx n="84" d="100"/>
          <a:sy n="84" d="100"/>
        </p:scale>
        <p:origin x="1620" y="-17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&#25239;&#37240;&#21270;&#29289;&#36074;&#12486;&#12441;&#12540;&#12479;\&#29983;&#23384;&#25968;&#12392;&#40802;&#12398;&#25512;&#3122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Scietific_Report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&#25239;&#37240;&#21270;&#29289;&#36074;&#12486;&#12441;&#12540;&#12479;\&#29983;&#23384;&#25968;&#12392;&#40802;&#12398;&#25512;&#31227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&#25239;&#37240;&#21270;&#29289;&#36074;&#12486;&#12441;&#12540;&#12479;\&#29983;&#23384;&#25968;&#12392;&#40802;&#12398;&#25512;&#31227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&#25239;&#37240;&#21270;&#29289;&#36074;&#12486;&#12441;&#12540;&#12479;\&#29983;&#23384;&#25968;&#12392;&#40802;&#12398;&#25512;&#31227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&#25239;&#37240;&#21270;&#29289;&#36074;&#12486;&#12441;&#12540;&#12479;\&#29983;&#23384;&#25968;&#12392;&#40802;&#12398;&#25512;&#31227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&#25239;&#37240;&#21270;&#29289;&#36074;&#12486;&#12441;&#12540;&#12479;\&#29983;&#23384;&#25968;&#12392;&#40802;&#12398;&#25512;&#31227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&#25239;&#37240;&#21270;&#29289;&#36074;&#12486;&#12441;&#12540;&#12479;\&#29983;&#23384;&#25968;&#12392;&#40802;&#12398;&#25512;&#31227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Scietific_Report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&#25239;&#37240;&#21270;&#29289;&#36074;&#12486;&#12441;&#12540;&#12479;\&#29983;&#23384;&#25968;&#12392;&#40802;&#12398;&#25512;&#31227;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Cys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[65]</a:t>
            </a:r>
            <a:endParaRPr lang="ja-JP" sz="8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4304605541119328"/>
          <c:y val="0.3580620854813080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3331912714146038"/>
          <c:y val="0.35461304750039169"/>
          <c:w val="0.82623375999198589"/>
          <c:h val="0.5089370976044642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死亡率と生存数の推移(L-システイン類縁体)'!$B$121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20:$R$12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21:$R$121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521-2841-BCC7-5FFEFD9C3170}"/>
            </c:ext>
          </c:extLst>
        </c:ser>
        <c:ser>
          <c:idx val="1"/>
          <c:order val="1"/>
          <c:tx>
            <c:strRef>
              <c:f>'死亡率と生存数の推移(L-システイン類縁体)'!$B$122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20:$R$12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22:$R$122</c:f>
              <c:numCache>
                <c:formatCode>0_);[Red]\(0\)</c:formatCode>
                <c:ptCount val="16"/>
                <c:pt idx="0">
                  <c:v>100</c:v>
                </c:pt>
                <c:pt idx="1">
                  <c:v>95.384615384615387</c:v>
                </c:pt>
                <c:pt idx="2">
                  <c:v>58.461538461538467</c:v>
                </c:pt>
                <c:pt idx="3">
                  <c:v>24.615384615384617</c:v>
                </c:pt>
                <c:pt idx="4">
                  <c:v>10.76923076923077</c:v>
                </c:pt>
                <c:pt idx="5">
                  <c:v>4.6153846153846159</c:v>
                </c:pt>
                <c:pt idx="6">
                  <c:v>3.0769230769230771</c:v>
                </c:pt>
                <c:pt idx="7">
                  <c:v>1.5384615384615385</c:v>
                </c:pt>
                <c:pt idx="8">
                  <c:v>1.5384615384615385</c:v>
                </c:pt>
                <c:pt idx="9">
                  <c:v>1.5384615384615385</c:v>
                </c:pt>
                <c:pt idx="10">
                  <c:v>1.5384615384615385</c:v>
                </c:pt>
                <c:pt idx="11">
                  <c:v>1.5384615384615385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521-2841-BCC7-5FFEFD9C3170}"/>
            </c:ext>
          </c:extLst>
        </c:ser>
        <c:ser>
          <c:idx val="2"/>
          <c:order val="2"/>
          <c:tx>
            <c:strRef>
              <c:f>'死亡率と生存数の推移(L-システイン類縁体)'!$B$123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20:$R$12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23:$R$123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16.923076923076923</c:v>
                </c:pt>
                <c:pt idx="3">
                  <c:v>41.53846153846154</c:v>
                </c:pt>
                <c:pt idx="4">
                  <c:v>35.384615384615387</c:v>
                </c:pt>
                <c:pt idx="5">
                  <c:v>32.307692307692307</c:v>
                </c:pt>
                <c:pt idx="6">
                  <c:v>29.230769230769234</c:v>
                </c:pt>
                <c:pt idx="7">
                  <c:v>23.076923076923077</c:v>
                </c:pt>
                <c:pt idx="8">
                  <c:v>20</c:v>
                </c:pt>
                <c:pt idx="9">
                  <c:v>15.384615384615385</c:v>
                </c:pt>
                <c:pt idx="10">
                  <c:v>4.6153846153846159</c:v>
                </c:pt>
                <c:pt idx="11">
                  <c:v>4.6153846153846159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521-2841-BCC7-5FFEFD9C3170}"/>
            </c:ext>
          </c:extLst>
        </c:ser>
        <c:ser>
          <c:idx val="3"/>
          <c:order val="3"/>
          <c:tx>
            <c:strRef>
              <c:f>'死亡率と生存数の推移(L-システイン類縁体)'!$B$124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20:$R$12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24:$R$124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521-2841-BCC7-5FFEFD9C3170}"/>
            </c:ext>
          </c:extLst>
        </c:ser>
        <c:ser>
          <c:idx val="4"/>
          <c:order val="4"/>
          <c:tx>
            <c:strRef>
              <c:f>'死亡率と生存数の推移(L-システイン類縁体)'!$B$125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rgbClr val="6B5207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20:$R$12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25:$R$125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521-2841-BCC7-5FFEFD9C31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51696272"/>
        <c:axId val="451891776"/>
      </c:barChart>
      <c:catAx>
        <c:axId val="451696272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high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451891776"/>
        <c:crosses val="autoZero"/>
        <c:auto val="1"/>
        <c:lblAlgn val="ctr"/>
        <c:lblOffset val="100"/>
        <c:noMultiLvlLbl val="0"/>
      </c:catAx>
      <c:valAx>
        <c:axId val="451891776"/>
        <c:scaling>
          <c:orientation val="minMax"/>
          <c:max val="120"/>
        </c:scaling>
        <c:delete val="0"/>
        <c:axPos val="l"/>
        <c:numFmt formatCode="0_);[Red]\(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451696272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legend>
      <c:legendPos val="b"/>
      <c:legendEntry>
        <c:idx val="0"/>
        <c:delete val="1"/>
      </c:legendEntry>
      <c:layout>
        <c:manualLayout>
          <c:xMode val="edge"/>
          <c:yMode val="edge"/>
          <c:x val="0.26690833929345614"/>
          <c:y val="6.1639722174558528E-2"/>
          <c:w val="0.50889358761258674"/>
          <c:h val="7.7946937420724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/>
              </a:solidFill>
              <a:latin typeface="Meiryo" panose="020B0604030504040204" pitchFamily="34" charset="-128"/>
              <a:ea typeface="Meiryo" panose="020B0604030504040204" pitchFamily="34" charset="-128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9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MME [47]</a:t>
            </a:r>
            <a:endParaRPr lang="ja-JP" sz="9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4078090277777774"/>
          <c:y val="0.2394224250503910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Fig.S4(L-Methionine_derivative)'!$B$52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Fig.S4(L-Methionine_derivative)'!$C$51:$R$51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S4(L-Methionine_derivative)'!$C$52:$R$52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C5-2245-8340-44AB93666CF4}"/>
            </c:ext>
          </c:extLst>
        </c:ser>
        <c:ser>
          <c:idx val="1"/>
          <c:order val="1"/>
          <c:tx>
            <c:strRef>
              <c:f>'Fig.S4(L-Methionine_derivative)'!$B$53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Fig.S4(L-Methionine_derivative)'!$C$51:$R$51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S4(L-Methionine_derivative)'!$C$53:$R$53</c:f>
              <c:numCache>
                <c:formatCode>0_);[Red]\(0\)</c:formatCode>
                <c:ptCount val="16"/>
                <c:pt idx="0">
                  <c:v>100</c:v>
                </c:pt>
                <c:pt idx="1">
                  <c:v>100</c:v>
                </c:pt>
                <c:pt idx="2">
                  <c:v>34.042553191489361</c:v>
                </c:pt>
                <c:pt idx="3">
                  <c:v>6.3829787234042552</c:v>
                </c:pt>
                <c:pt idx="4">
                  <c:v>6.382978723404255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0C5-2245-8340-44AB93666CF4}"/>
            </c:ext>
          </c:extLst>
        </c:ser>
        <c:ser>
          <c:idx val="2"/>
          <c:order val="2"/>
          <c:tx>
            <c:strRef>
              <c:f>'Fig.S4(L-Methionine_derivative)'!$B$54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numRef>
              <c:f>'Fig.S4(L-Methionine_derivative)'!$C$51:$R$51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S4(L-Methionine_derivative)'!$C$54:$R$54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65.957446808510639</c:v>
                </c:pt>
                <c:pt idx="3">
                  <c:v>93.61702127659575</c:v>
                </c:pt>
                <c:pt idx="4">
                  <c:v>93.61702127659575</c:v>
                </c:pt>
                <c:pt idx="5">
                  <c:v>100</c:v>
                </c:pt>
                <c:pt idx="6">
                  <c:v>42.553191489361701</c:v>
                </c:pt>
                <c:pt idx="7">
                  <c:v>23.404255319148938</c:v>
                </c:pt>
                <c:pt idx="8">
                  <c:v>6.3829787234042552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0C5-2245-8340-44AB93666CF4}"/>
            </c:ext>
          </c:extLst>
        </c:ser>
        <c:ser>
          <c:idx val="3"/>
          <c:order val="3"/>
          <c:tx>
            <c:strRef>
              <c:f>'Fig.S4(L-Methionine_derivative)'!$B$55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'Fig.S4(L-Methionine_derivative)'!$C$51:$R$51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S4(L-Methionine_derivative)'!$C$55:$R$55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7.446808510638306</c:v>
                </c:pt>
                <c:pt idx="7">
                  <c:v>74.468085106382972</c:v>
                </c:pt>
                <c:pt idx="8">
                  <c:v>74.468085106382972</c:v>
                </c:pt>
                <c:pt idx="9">
                  <c:v>74.468085106382972</c:v>
                </c:pt>
                <c:pt idx="10">
                  <c:v>63.829787234042556</c:v>
                </c:pt>
                <c:pt idx="11">
                  <c:v>53.191489361702125</c:v>
                </c:pt>
                <c:pt idx="12">
                  <c:v>53.191489361702125</c:v>
                </c:pt>
                <c:pt idx="13">
                  <c:v>29.787234042553191</c:v>
                </c:pt>
                <c:pt idx="14">
                  <c:v>6.3829787234042552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0C5-2245-8340-44AB93666CF4}"/>
            </c:ext>
          </c:extLst>
        </c:ser>
        <c:ser>
          <c:idx val="4"/>
          <c:order val="4"/>
          <c:tx>
            <c:strRef>
              <c:f>'Fig.S4(L-Methionine_derivative)'!$B$56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numRef>
              <c:f>'Fig.S4(L-Methionine_derivative)'!$C$51:$R$51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S4(L-Methionine_derivative)'!$C$56:$R$56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0C5-2245-8340-44AB93666C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2729231"/>
        <c:axId val="182730959"/>
      </c:barChart>
      <c:catAx>
        <c:axId val="182729231"/>
        <c:scaling>
          <c:orientation val="minMax"/>
        </c:scaling>
        <c:delete val="0"/>
        <c:axPos val="b"/>
        <c:numFmt formatCode="0_);[Red]\(0\)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82730959"/>
        <c:crosses val="autoZero"/>
        <c:auto val="1"/>
        <c:lblAlgn val="ctr"/>
        <c:lblOffset val="100"/>
        <c:noMultiLvlLbl val="0"/>
      </c:catAx>
      <c:valAx>
        <c:axId val="182730959"/>
        <c:scaling>
          <c:orientation val="minMax"/>
          <c:max val="120"/>
        </c:scaling>
        <c:delete val="0"/>
        <c:axPos val="l"/>
        <c:numFmt formatCode="0_);[Red]\(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82729231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AC [74] </a:t>
            </a:r>
            <a:endParaRPr lang="ja-JP" sz="8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3737335314211235"/>
          <c:y val="0.252159531519724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29983030908875"/>
          <c:y val="0.2473530470784239"/>
          <c:w val="0.82617899974870834"/>
          <c:h val="0.62766562197170639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死亡率と生存数の推移(L-システイン類縁体)'!$B$86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85:$R$8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86:$R$86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49-024C-9404-BC1842095274}"/>
            </c:ext>
          </c:extLst>
        </c:ser>
        <c:ser>
          <c:idx val="1"/>
          <c:order val="1"/>
          <c:tx>
            <c:strRef>
              <c:f>'死亡率と生存数の推移(L-システイン類縁体)'!$B$87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85:$R$8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87:$R$87</c:f>
              <c:numCache>
                <c:formatCode>0_);[Red]\(0\)</c:formatCode>
                <c:ptCount val="16"/>
                <c:pt idx="0">
                  <c:v>95.945945945945937</c:v>
                </c:pt>
                <c:pt idx="1">
                  <c:v>72.972972972972968</c:v>
                </c:pt>
                <c:pt idx="2">
                  <c:v>56.756756756756758</c:v>
                </c:pt>
                <c:pt idx="3">
                  <c:v>47.297297297297298</c:v>
                </c:pt>
                <c:pt idx="4">
                  <c:v>35.135135135135137</c:v>
                </c:pt>
                <c:pt idx="5">
                  <c:v>22.972972972972975</c:v>
                </c:pt>
                <c:pt idx="6">
                  <c:v>13.513513513513514</c:v>
                </c:pt>
                <c:pt idx="7">
                  <c:v>10.810810810810811</c:v>
                </c:pt>
                <c:pt idx="8">
                  <c:v>2.7027027027027026</c:v>
                </c:pt>
                <c:pt idx="9">
                  <c:v>2.7027027027027026</c:v>
                </c:pt>
                <c:pt idx="10">
                  <c:v>2.7027027027027026</c:v>
                </c:pt>
                <c:pt idx="11">
                  <c:v>1.3513513513513513</c:v>
                </c:pt>
                <c:pt idx="12">
                  <c:v>1.3513513513513513</c:v>
                </c:pt>
                <c:pt idx="13">
                  <c:v>1.3513513513513513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649-024C-9404-BC1842095274}"/>
            </c:ext>
          </c:extLst>
        </c:ser>
        <c:ser>
          <c:idx val="2"/>
          <c:order val="2"/>
          <c:tx>
            <c:strRef>
              <c:f>'死亡率と生存数の推移(L-システイン類縁体)'!$B$88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85:$R$8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88:$R$88</c:f>
              <c:numCache>
                <c:formatCode>0_);[Red]\(0\)</c:formatCode>
                <c:ptCount val="16"/>
                <c:pt idx="0">
                  <c:v>4.0540540540540544</c:v>
                </c:pt>
                <c:pt idx="1">
                  <c:v>27.027027027027028</c:v>
                </c:pt>
                <c:pt idx="2">
                  <c:v>43.243243243243242</c:v>
                </c:pt>
                <c:pt idx="3">
                  <c:v>52.702702702702695</c:v>
                </c:pt>
                <c:pt idx="4">
                  <c:v>63.513513513513509</c:v>
                </c:pt>
                <c:pt idx="5">
                  <c:v>72.972972972972968</c:v>
                </c:pt>
                <c:pt idx="6">
                  <c:v>77.027027027027032</c:v>
                </c:pt>
                <c:pt idx="7">
                  <c:v>63.513513513513509</c:v>
                </c:pt>
                <c:pt idx="8">
                  <c:v>58.108108108108105</c:v>
                </c:pt>
                <c:pt idx="9">
                  <c:v>40.54054054054054</c:v>
                </c:pt>
                <c:pt idx="10">
                  <c:v>39.189189189189186</c:v>
                </c:pt>
                <c:pt idx="11">
                  <c:v>9.4594594594594597</c:v>
                </c:pt>
                <c:pt idx="12">
                  <c:v>4.0540540540540544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649-024C-9404-BC1842095274}"/>
            </c:ext>
          </c:extLst>
        </c:ser>
        <c:ser>
          <c:idx val="3"/>
          <c:order val="3"/>
          <c:tx>
            <c:strRef>
              <c:f>'死亡率と生存数の推移(L-システイン類縁体)'!$B$89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rgbClr val="DDCE76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85:$R$8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89:$R$89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9.4594594594594597</c:v>
                </c:pt>
                <c:pt idx="8">
                  <c:v>13.513513513513514</c:v>
                </c:pt>
                <c:pt idx="9">
                  <c:v>28.378378378378379</c:v>
                </c:pt>
                <c:pt idx="10">
                  <c:v>29.72972972972973</c:v>
                </c:pt>
                <c:pt idx="11">
                  <c:v>31.081081081081081</c:v>
                </c:pt>
                <c:pt idx="12">
                  <c:v>21.621621621621621</c:v>
                </c:pt>
                <c:pt idx="13">
                  <c:v>14.864864864864865</c:v>
                </c:pt>
                <c:pt idx="14">
                  <c:v>10.810810810810811</c:v>
                </c:pt>
                <c:pt idx="15">
                  <c:v>6.7567567567567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649-024C-9404-BC1842095274}"/>
            </c:ext>
          </c:extLst>
        </c:ser>
        <c:ser>
          <c:idx val="4"/>
          <c:order val="4"/>
          <c:tx>
            <c:strRef>
              <c:f>'死亡率と生存数の推移(L-システイン類縁体)'!$B$90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85:$R$8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90:$R$90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649-024C-9404-BC18420952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13242559"/>
        <c:axId val="512894671"/>
      </c:barChart>
      <c:catAx>
        <c:axId val="513242559"/>
        <c:scaling>
          <c:orientation val="minMax"/>
        </c:scaling>
        <c:delete val="1"/>
        <c:axPos val="b"/>
        <c:numFmt formatCode="0_);[Red]\(0\)" sourceLinked="1"/>
        <c:majorTickMark val="out"/>
        <c:minorTickMark val="none"/>
        <c:tickLblPos val="nextTo"/>
        <c:crossAx val="512894671"/>
        <c:crosses val="autoZero"/>
        <c:auto val="1"/>
        <c:lblAlgn val="ctr"/>
        <c:lblOffset val="100"/>
        <c:noMultiLvlLbl val="0"/>
      </c:catAx>
      <c:valAx>
        <c:axId val="512894671"/>
        <c:scaling>
          <c:orientation val="minMax"/>
          <c:max val="120"/>
        </c:scaling>
        <c:delete val="0"/>
        <c:axPos val="l"/>
        <c:numFmt formatCode="0_);[Red]\(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513242559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CME [63]</a:t>
            </a:r>
            <a:endParaRPr lang="ja-JP" sz="8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3593917761308758"/>
          <c:y val="0.2552013481136835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2962726460017149"/>
          <c:y val="0.25606249647929946"/>
          <c:w val="0.8222829531188306"/>
          <c:h val="0.6602197396539346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死亡率と生存数の推移(L-システイン類縁体)'!$B$51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51:$R$51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D5-A841-BBF8-F6CBDC23A0E3}"/>
            </c:ext>
          </c:extLst>
        </c:ser>
        <c:ser>
          <c:idx val="1"/>
          <c:order val="1"/>
          <c:tx>
            <c:strRef>
              <c:f>'死亡率と生存数の推移(L-システイン類縁体)'!$B$52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52:$R$52</c:f>
              <c:numCache>
                <c:formatCode>0_);[Red]\(0\)</c:formatCode>
                <c:ptCount val="16"/>
                <c:pt idx="0">
                  <c:v>100</c:v>
                </c:pt>
                <c:pt idx="1">
                  <c:v>68.253968253968253</c:v>
                </c:pt>
                <c:pt idx="2">
                  <c:v>57.142857142857139</c:v>
                </c:pt>
                <c:pt idx="3">
                  <c:v>14.285714285714285</c:v>
                </c:pt>
                <c:pt idx="4">
                  <c:v>9.5238095238095237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0D5-A841-BBF8-F6CBDC23A0E3}"/>
            </c:ext>
          </c:extLst>
        </c:ser>
        <c:ser>
          <c:idx val="2"/>
          <c:order val="2"/>
          <c:tx>
            <c:strRef>
              <c:f>'死亡率と生存数の推移(L-システイン類縁体)'!$B$53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53:$R$53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1.5873015873015872</c:v>
                </c:pt>
                <c:pt idx="3">
                  <c:v>26.984126984126984</c:v>
                </c:pt>
                <c:pt idx="4">
                  <c:v>9.5238095238095237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0D5-A841-BBF8-F6CBDC23A0E3}"/>
            </c:ext>
          </c:extLst>
        </c:ser>
        <c:ser>
          <c:idx val="3"/>
          <c:order val="3"/>
          <c:tx>
            <c:strRef>
              <c:f>'死亡率と生存数の推移(L-システイン類縁体)'!$B$54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54:$R$54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0D5-A841-BBF8-F6CBDC23A0E3}"/>
            </c:ext>
          </c:extLst>
        </c:ser>
        <c:ser>
          <c:idx val="4"/>
          <c:order val="4"/>
          <c:tx>
            <c:strRef>
              <c:f>'死亡率と生存数の推移(L-システイン類縁体)'!$B$55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55:$R$55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0D5-A841-BBF8-F6CBDC23A0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2729231"/>
        <c:axId val="182730959"/>
      </c:barChart>
      <c:catAx>
        <c:axId val="182729231"/>
        <c:scaling>
          <c:orientation val="minMax"/>
        </c:scaling>
        <c:delete val="1"/>
        <c:axPos val="b"/>
        <c:numFmt formatCode="0_);[Red]\(0\)" sourceLinked="1"/>
        <c:majorTickMark val="out"/>
        <c:minorTickMark val="none"/>
        <c:tickLblPos val="nextTo"/>
        <c:crossAx val="182730959"/>
        <c:crosses val="autoZero"/>
        <c:auto val="1"/>
        <c:lblAlgn val="ctr"/>
        <c:lblOffset val="100"/>
        <c:noMultiLvlLbl val="0"/>
      </c:catAx>
      <c:valAx>
        <c:axId val="182730959"/>
        <c:scaling>
          <c:orientation val="minMax"/>
          <c:max val="120"/>
        </c:scaling>
        <c:delete val="0"/>
        <c:axPos val="l"/>
        <c:numFmt formatCode="0_);[Red]\(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82729231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CEE [44] </a:t>
            </a:r>
            <a:endParaRPr lang="ja-JP" sz="8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3762577860078257"/>
          <c:y val="0.2260510997177860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2946682284810163"/>
          <c:y val="0.23315501251737919"/>
          <c:w val="0.82250291636855477"/>
          <c:h val="0.59400311679467788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死亡率と生存数の推移(L-システイン類縁体)'!$B$160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59:$R$159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60:$R$160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0A-E14E-95B0-6C9C87F96994}"/>
            </c:ext>
          </c:extLst>
        </c:ser>
        <c:ser>
          <c:idx val="1"/>
          <c:order val="1"/>
          <c:tx>
            <c:strRef>
              <c:f>'死亡率と生存数の推移(L-システイン類縁体)'!$B$161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59:$R$159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61:$R$161</c:f>
              <c:numCache>
                <c:formatCode>0_);[Red]\(0\)</c:formatCode>
                <c:ptCount val="16"/>
                <c:pt idx="0">
                  <c:v>100</c:v>
                </c:pt>
                <c:pt idx="1">
                  <c:v>93.181818181818173</c:v>
                </c:pt>
                <c:pt idx="2">
                  <c:v>90.909090909090907</c:v>
                </c:pt>
                <c:pt idx="3">
                  <c:v>86.36363636363636</c:v>
                </c:pt>
                <c:pt idx="4">
                  <c:v>65.909090909090907</c:v>
                </c:pt>
                <c:pt idx="5">
                  <c:v>34.090909090909086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70A-E14E-95B0-6C9C87F96994}"/>
            </c:ext>
          </c:extLst>
        </c:ser>
        <c:ser>
          <c:idx val="2"/>
          <c:order val="2"/>
          <c:tx>
            <c:strRef>
              <c:f>'死亡率と生存数の推移(L-システイン類縁体)'!$B$162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59:$R$159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62:$R$162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70A-E14E-95B0-6C9C87F96994}"/>
            </c:ext>
          </c:extLst>
        </c:ser>
        <c:ser>
          <c:idx val="3"/>
          <c:order val="3"/>
          <c:tx>
            <c:strRef>
              <c:f>'死亡率と生存数の推移(L-システイン類縁体)'!$B$163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59:$R$159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63:$R$163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70A-E14E-95B0-6C9C87F96994}"/>
            </c:ext>
          </c:extLst>
        </c:ser>
        <c:ser>
          <c:idx val="4"/>
          <c:order val="4"/>
          <c:tx>
            <c:strRef>
              <c:f>'死亡率と生存数の推移(L-システイン類縁体)'!$B$164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numRef>
              <c:f>'死亡率と生存数の推移(L-システイン類縁体)'!$C$159:$R$159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システイン類縁体)'!$C$164:$R$164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70A-E14E-95B0-6C9C87F969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51976640"/>
        <c:axId val="452546032"/>
      </c:barChart>
      <c:catAx>
        <c:axId val="451976640"/>
        <c:scaling>
          <c:orientation val="minMax"/>
        </c:scaling>
        <c:delete val="0"/>
        <c:axPos val="b"/>
        <c:numFmt formatCode="0_);[Red]\(0\)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452546032"/>
        <c:crosses val="autoZero"/>
        <c:auto val="1"/>
        <c:lblAlgn val="ctr"/>
        <c:lblOffset val="100"/>
        <c:noMultiLvlLbl val="0"/>
      </c:catAx>
      <c:valAx>
        <c:axId val="452546032"/>
        <c:scaling>
          <c:orientation val="minMax"/>
          <c:max val="120"/>
        </c:scaling>
        <c:delete val="0"/>
        <c:axPos val="l"/>
        <c:numFmt formatCode="0_);[Red]\(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451976640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-AET [40] </a:t>
            </a:r>
            <a:endParaRPr lang="ja-JP" sz="8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0660098687210682"/>
          <c:y val="0.229639138263111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0603483523281085"/>
          <c:y val="0.23320578544556891"/>
          <c:w val="0.74274783016567614"/>
          <c:h val="0.61470877657179435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死亡率と生存数の推移(2-AET)'!$B$16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死亡率と生存数の推移(2-AET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2-AET)'!$C$16:$R$16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686-D54E-B990-3384F4D47097}"/>
            </c:ext>
          </c:extLst>
        </c:ser>
        <c:ser>
          <c:idx val="1"/>
          <c:order val="1"/>
          <c:tx>
            <c:strRef>
              <c:f>'死亡率と生存数の推移(2-AET)'!$B$17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死亡率と生存数の推移(2-AET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2-AET)'!$C$17:$R$17</c:f>
              <c:numCache>
                <c:formatCode>0_);[Red]\(0\)</c:formatCode>
                <c:ptCount val="16"/>
                <c:pt idx="0">
                  <c:v>100</c:v>
                </c:pt>
                <c:pt idx="1">
                  <c:v>95</c:v>
                </c:pt>
                <c:pt idx="2">
                  <c:v>95</c:v>
                </c:pt>
                <c:pt idx="3">
                  <c:v>75</c:v>
                </c:pt>
                <c:pt idx="4">
                  <c:v>35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686-D54E-B990-3384F4D47097}"/>
            </c:ext>
          </c:extLst>
        </c:ser>
        <c:ser>
          <c:idx val="2"/>
          <c:order val="2"/>
          <c:tx>
            <c:strRef>
              <c:f>'死亡率と生存数の推移(2-AET)'!$B$18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numRef>
              <c:f>'死亡率と生存数の推移(2-AET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2-AET)'!$C$18:$R$18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</c:v>
                </c:pt>
                <c:pt idx="4">
                  <c:v>10</c:v>
                </c:pt>
                <c:pt idx="5">
                  <c:v>7.5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686-D54E-B990-3384F4D47097}"/>
            </c:ext>
          </c:extLst>
        </c:ser>
        <c:ser>
          <c:idx val="3"/>
          <c:order val="3"/>
          <c:tx>
            <c:strRef>
              <c:f>'死亡率と生存数の推移(2-AET)'!$B$19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'死亡率と生存数の推移(2-AET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2-AET)'!$C$19:$R$19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686-D54E-B990-3384F4D47097}"/>
            </c:ext>
          </c:extLst>
        </c:ser>
        <c:ser>
          <c:idx val="4"/>
          <c:order val="4"/>
          <c:tx>
            <c:strRef>
              <c:f>'死亡率と生存数の推移(2-AET)'!$B$20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numRef>
              <c:f>'死亡率と生存数の推移(2-AET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2-AET)'!$C$20:$R$20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686-D54E-B990-3384F4D470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2843983"/>
        <c:axId val="182845983"/>
      </c:barChart>
      <c:catAx>
        <c:axId val="182843983"/>
        <c:scaling>
          <c:orientation val="minMax"/>
        </c:scaling>
        <c:delete val="0"/>
        <c:axPos val="b"/>
        <c:numFmt formatCode="0_);[Red]\(0\)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82845983"/>
        <c:crosses val="autoZero"/>
        <c:auto val="1"/>
        <c:lblAlgn val="ctr"/>
        <c:lblOffset val="100"/>
        <c:noMultiLvlLbl val="0"/>
      </c:catAx>
      <c:valAx>
        <c:axId val="182845983"/>
        <c:scaling>
          <c:orientation val="minMax"/>
          <c:max val="1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defRPr>
                </a:pPr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Survival rate (%)</a:t>
                </a:r>
                <a:endParaRPr lang="ja-JP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0_);[Red]\(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82843983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0" i="0" u="none" strike="noStrike" kern="1200" spc="0" baseline="0">
                <a:solidFill>
                  <a:schemeClr val="tx1"/>
                </a:solidFill>
                <a:latin typeface="Meiryo" panose="020B0604030504040204" pitchFamily="34" charset="-128"/>
                <a:ea typeface="Meiryo" panose="020B0604030504040204" pitchFamily="34" charset="-128"/>
                <a:cs typeface="+mn-cs"/>
              </a:defRPr>
            </a:pPr>
            <a:r>
              <a:rPr lang="en-US" sz="600" dirty="0"/>
              <a:t>D</a:t>
            </a:r>
            <a:r>
              <a:rPr lang="en-US" sz="800" dirty="0"/>
              <a:t>-</a:t>
            </a:r>
            <a:r>
              <a:rPr lang="en-US" sz="800" dirty="0" err="1"/>
              <a:t>Cys</a:t>
            </a:r>
            <a:r>
              <a:rPr lang="en-US" sz="800" dirty="0"/>
              <a:t> [36]</a:t>
            </a:r>
            <a:endParaRPr lang="ja-JP" sz="800"/>
          </a:p>
        </c:rich>
      </c:tx>
      <c:layout>
        <c:manualLayout>
          <c:xMode val="edge"/>
          <c:yMode val="edge"/>
          <c:x val="0.13168651812889506"/>
          <c:y val="0.3057897869421922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00" b="0" i="0" u="none" strike="noStrike" kern="1200" spc="0" baseline="0">
              <a:solidFill>
                <a:schemeClr val="tx1"/>
              </a:solidFill>
              <a:latin typeface="Meiryo" panose="020B0604030504040204" pitchFamily="34" charset="-128"/>
              <a:ea typeface="Meiryo" panose="020B0604030504040204" pitchFamily="34" charset="-128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死亡率と生存数の推移(D-システイン類縁体)'!$B$16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死亡率と生存数の推移(D-システイ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D-システイン類縁体)'!$C$16:$R$16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47-D645-AD77-82EC09C3C532}"/>
            </c:ext>
          </c:extLst>
        </c:ser>
        <c:ser>
          <c:idx val="1"/>
          <c:order val="1"/>
          <c:tx>
            <c:strRef>
              <c:f>'死亡率と生存数の推移(D-システイン類縁体)'!$B$17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死亡率と生存数の推移(D-システイ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D-システイン類縁体)'!$C$17:$R$17</c:f>
              <c:numCache>
                <c:formatCode>0_);[Red]\(0\)</c:formatCode>
                <c:ptCount val="16"/>
                <c:pt idx="0">
                  <c:v>100</c:v>
                </c:pt>
                <c:pt idx="1">
                  <c:v>91.666666666666657</c:v>
                </c:pt>
                <c:pt idx="2">
                  <c:v>66.666666666666657</c:v>
                </c:pt>
                <c:pt idx="3">
                  <c:v>41.666666666666671</c:v>
                </c:pt>
                <c:pt idx="4">
                  <c:v>25</c:v>
                </c:pt>
                <c:pt idx="5">
                  <c:v>16.666666666666664</c:v>
                </c:pt>
                <c:pt idx="6">
                  <c:v>11.111111111111111</c:v>
                </c:pt>
                <c:pt idx="7">
                  <c:v>2.7777777777777777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747-D645-AD77-82EC09C3C532}"/>
            </c:ext>
          </c:extLst>
        </c:ser>
        <c:ser>
          <c:idx val="2"/>
          <c:order val="2"/>
          <c:tx>
            <c:strRef>
              <c:f>'死亡率と生存数の推移(D-システイン類縁体)'!$B$18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numRef>
              <c:f>'死亡率と生存数の推移(D-システイ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D-システイン類縁体)'!$C$18:$R$18</c:f>
              <c:numCache>
                <c:formatCode>0_);[Red]\(0\)</c:formatCode>
                <c:ptCount val="16"/>
                <c:pt idx="0">
                  <c:v>0</c:v>
                </c:pt>
                <c:pt idx="1">
                  <c:v>5.5555555555555554</c:v>
                </c:pt>
                <c:pt idx="2">
                  <c:v>25</c:v>
                </c:pt>
                <c:pt idx="3">
                  <c:v>44.444444444444443</c:v>
                </c:pt>
                <c:pt idx="4">
                  <c:v>58.333333333333336</c:v>
                </c:pt>
                <c:pt idx="5">
                  <c:v>63.888888888888886</c:v>
                </c:pt>
                <c:pt idx="6">
                  <c:v>61.111111111111114</c:v>
                </c:pt>
                <c:pt idx="7">
                  <c:v>52.777777777777779</c:v>
                </c:pt>
                <c:pt idx="8">
                  <c:v>52.777777777777779</c:v>
                </c:pt>
                <c:pt idx="9">
                  <c:v>30.555555555555557</c:v>
                </c:pt>
                <c:pt idx="10">
                  <c:v>30.555555555555557</c:v>
                </c:pt>
                <c:pt idx="11">
                  <c:v>19.444444444444446</c:v>
                </c:pt>
                <c:pt idx="12">
                  <c:v>19.444444444444446</c:v>
                </c:pt>
                <c:pt idx="13">
                  <c:v>19.444444444444446</c:v>
                </c:pt>
                <c:pt idx="14">
                  <c:v>13.888888888888889</c:v>
                </c:pt>
                <c:pt idx="15">
                  <c:v>11.11111111111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747-D645-AD77-82EC09C3C532}"/>
            </c:ext>
          </c:extLst>
        </c:ser>
        <c:ser>
          <c:idx val="3"/>
          <c:order val="3"/>
          <c:tx>
            <c:strRef>
              <c:f>'死亡率と生存数の推移(D-システイン類縁体)'!$B$19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rgbClr val="DDCE76"/>
            </a:solidFill>
            <a:ln>
              <a:noFill/>
            </a:ln>
            <a:effectLst/>
          </c:spPr>
          <c:invertIfNegative val="0"/>
          <c:cat>
            <c:numRef>
              <c:f>'死亡率と生存数の推移(D-システイ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D-システイン類縁体)'!$C$19:$R$19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.5555555555555554</c:v>
                </c:pt>
                <c:pt idx="7">
                  <c:v>19.444444444444446</c:v>
                </c:pt>
                <c:pt idx="8">
                  <c:v>22.222222222222221</c:v>
                </c:pt>
                <c:pt idx="9">
                  <c:v>41.666666666666671</c:v>
                </c:pt>
                <c:pt idx="10">
                  <c:v>41.666666666666671</c:v>
                </c:pt>
                <c:pt idx="11">
                  <c:v>52.777777777777779</c:v>
                </c:pt>
                <c:pt idx="12">
                  <c:v>47.222222222222221</c:v>
                </c:pt>
                <c:pt idx="13">
                  <c:v>25</c:v>
                </c:pt>
                <c:pt idx="14">
                  <c:v>16.666666666666664</c:v>
                </c:pt>
                <c:pt idx="15">
                  <c:v>11.11111111111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747-D645-AD77-82EC09C3C532}"/>
            </c:ext>
          </c:extLst>
        </c:ser>
        <c:ser>
          <c:idx val="4"/>
          <c:order val="4"/>
          <c:tx>
            <c:strRef>
              <c:f>'死亡率と生存数の推移(D-システイン類縁体)'!$B$20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rgbClr val="882155"/>
            </a:solidFill>
            <a:ln>
              <a:noFill/>
            </a:ln>
            <a:effectLst/>
          </c:spPr>
          <c:invertIfNegative val="0"/>
          <c:cat>
            <c:numRef>
              <c:f>'死亡率と生存数の推移(D-システイ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D-システイン類縁体)'!$C$20:$R$20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1.111111111111111</c:v>
                </c:pt>
                <c:pt idx="14">
                  <c:v>16.666666666666664</c:v>
                </c:pt>
                <c:pt idx="15">
                  <c:v>13.8888888888888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747-D645-AD77-82EC09C3C5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2843983"/>
        <c:axId val="182845983"/>
      </c:barChart>
      <c:catAx>
        <c:axId val="182843983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high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82845983"/>
        <c:crosses val="autoZero"/>
        <c:auto val="1"/>
        <c:lblAlgn val="ctr"/>
        <c:lblOffset val="100"/>
        <c:noMultiLvlLbl val="0"/>
      </c:catAx>
      <c:valAx>
        <c:axId val="182845983"/>
        <c:scaling>
          <c:orientation val="minMax"/>
          <c:max val="120"/>
        </c:scaling>
        <c:delete val="0"/>
        <c:axPos val="l"/>
        <c:numFmt formatCode="0_);[Red]\(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82843983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CME [38]</a:t>
            </a:r>
            <a:endParaRPr lang="ja-JP" sz="8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371625198149998"/>
          <c:y val="0.245301246919956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8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死亡率と生存数の推移(D-システイン類縁体)'!$B$51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死亡率と生存数の推移(D-システイン類縁体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D-システイン類縁体)'!$C$51:$R$51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BE-3342-A784-0E63F79F6170}"/>
            </c:ext>
          </c:extLst>
        </c:ser>
        <c:ser>
          <c:idx val="1"/>
          <c:order val="1"/>
          <c:tx>
            <c:strRef>
              <c:f>'死亡率と生存数の推移(D-システイン類縁体)'!$B$52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死亡率と生存数の推移(D-システイン類縁体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D-システイン類縁体)'!$C$52:$R$52</c:f>
              <c:numCache>
                <c:formatCode>0_);[Red]\(0\)</c:formatCode>
                <c:ptCount val="16"/>
                <c:pt idx="0">
                  <c:v>100</c:v>
                </c:pt>
                <c:pt idx="1">
                  <c:v>65.789473684210535</c:v>
                </c:pt>
                <c:pt idx="2">
                  <c:v>65.789473684210535</c:v>
                </c:pt>
                <c:pt idx="3">
                  <c:v>55.26315789473685</c:v>
                </c:pt>
                <c:pt idx="4">
                  <c:v>18.421052631578945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BBE-3342-A784-0E63F79F6170}"/>
            </c:ext>
          </c:extLst>
        </c:ser>
        <c:ser>
          <c:idx val="2"/>
          <c:order val="2"/>
          <c:tx>
            <c:strRef>
              <c:f>'死亡率と生存数の推移(D-システイン類縁体)'!$B$53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'死亡率と生存数の推移(D-システイン類縁体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D-システイン類縁体)'!$C$53:$R$53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BBE-3342-A784-0E63F79F6170}"/>
            </c:ext>
          </c:extLst>
        </c:ser>
        <c:ser>
          <c:idx val="3"/>
          <c:order val="3"/>
          <c:tx>
            <c:strRef>
              <c:f>'死亡率と生存数の推移(D-システイン類縁体)'!$B$54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'死亡率と生存数の推移(D-システイン類縁体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D-システイン類縁体)'!$C$54:$R$54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BBE-3342-A784-0E63F79F6170}"/>
            </c:ext>
          </c:extLst>
        </c:ser>
        <c:ser>
          <c:idx val="4"/>
          <c:order val="4"/>
          <c:tx>
            <c:strRef>
              <c:f>'死亡率と生存数の推移(D-システイン類縁体)'!$B$55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numRef>
              <c:f>'死亡率と生存数の推移(D-システイン類縁体)'!$C$50:$R$50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D-システイン類縁体)'!$C$55:$R$55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BBE-3342-A784-0E63F79F61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2729231"/>
        <c:axId val="182730959"/>
      </c:barChart>
      <c:catAx>
        <c:axId val="182729231"/>
        <c:scaling>
          <c:orientation val="minMax"/>
        </c:scaling>
        <c:delete val="1"/>
        <c:axPos val="b"/>
        <c:numFmt formatCode="0_);[Red]\(0\)" sourceLinked="1"/>
        <c:majorTickMark val="out"/>
        <c:minorTickMark val="none"/>
        <c:tickLblPos val="nextTo"/>
        <c:crossAx val="182730959"/>
        <c:crosses val="autoZero"/>
        <c:auto val="1"/>
        <c:lblAlgn val="ctr"/>
        <c:lblOffset val="100"/>
        <c:noMultiLvlLbl val="0"/>
      </c:catAx>
      <c:valAx>
        <c:axId val="182730959"/>
        <c:scaling>
          <c:orientation val="minMax"/>
          <c:max val="120"/>
        </c:scaling>
        <c:delete val="0"/>
        <c:axPos val="l"/>
        <c:numFmt formatCode="0_);[Red]\(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82729231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9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PA[47]</a:t>
            </a:r>
            <a:endParaRPr lang="ja-JP" sz="9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7116393520878215"/>
          <c:y val="0.216631782160136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5862867966512348"/>
          <c:y val="0.21709889776327523"/>
          <c:w val="0.7284891784245846"/>
          <c:h val="0.55187294872038095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Fig. S4(D-Cysteine_derivatives)'!$B$88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Fig. S4(D-Cysteine_derivatives)'!$C$87:$R$87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 S4(D-Cysteine_derivatives)'!$C$88:$R$88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6A-B44C-AD87-9DB8363D8BFC}"/>
            </c:ext>
          </c:extLst>
        </c:ser>
        <c:ser>
          <c:idx val="1"/>
          <c:order val="1"/>
          <c:tx>
            <c:strRef>
              <c:f>'Fig. S4(D-Cysteine_derivatives)'!$B$89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Fig. S4(D-Cysteine_derivatives)'!$C$87:$R$87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 S4(D-Cysteine_derivatives)'!$C$89:$R$89</c:f>
              <c:numCache>
                <c:formatCode>0_);[Red]\(0\)</c:formatCode>
                <c:ptCount val="16"/>
                <c:pt idx="0">
                  <c:v>100</c:v>
                </c:pt>
                <c:pt idx="1">
                  <c:v>100</c:v>
                </c:pt>
                <c:pt idx="2">
                  <c:v>23.404255319148938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86A-B44C-AD87-9DB8363D8BFC}"/>
            </c:ext>
          </c:extLst>
        </c:ser>
        <c:ser>
          <c:idx val="2"/>
          <c:order val="2"/>
          <c:tx>
            <c:strRef>
              <c:f>'Fig. S4(D-Cysteine_derivatives)'!$B$90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numRef>
              <c:f>'Fig. S4(D-Cysteine_derivatives)'!$C$87:$R$87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 S4(D-Cysteine_derivatives)'!$C$90:$R$90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76.59574468085107</c:v>
                </c:pt>
                <c:pt idx="3">
                  <c:v>100</c:v>
                </c:pt>
                <c:pt idx="4">
                  <c:v>95.744680851063833</c:v>
                </c:pt>
                <c:pt idx="5">
                  <c:v>70.212765957446805</c:v>
                </c:pt>
                <c:pt idx="6">
                  <c:v>68.085106382978722</c:v>
                </c:pt>
                <c:pt idx="7">
                  <c:v>65.957446808510639</c:v>
                </c:pt>
                <c:pt idx="8">
                  <c:v>65.957446808510639</c:v>
                </c:pt>
                <c:pt idx="9">
                  <c:v>63.829787234042556</c:v>
                </c:pt>
                <c:pt idx="10">
                  <c:v>61.702127659574465</c:v>
                </c:pt>
                <c:pt idx="11">
                  <c:v>61.702127659574465</c:v>
                </c:pt>
                <c:pt idx="12">
                  <c:v>59.574468085106382</c:v>
                </c:pt>
                <c:pt idx="13">
                  <c:v>51.063829787234042</c:v>
                </c:pt>
                <c:pt idx="14">
                  <c:v>36.170212765957451</c:v>
                </c:pt>
                <c:pt idx="15">
                  <c:v>29.7872340425531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86A-B44C-AD87-9DB8363D8BFC}"/>
            </c:ext>
          </c:extLst>
        </c:ser>
        <c:ser>
          <c:idx val="3"/>
          <c:order val="3"/>
          <c:tx>
            <c:strRef>
              <c:f>'Fig. S4(D-Cysteine_derivatives)'!$B$91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'Fig. S4(D-Cysteine_derivatives)'!$C$87:$R$87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 S4(D-Cysteine_derivatives)'!$C$91:$R$91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3.404255319148938</c:v>
                </c:pt>
                <c:pt idx="6">
                  <c:v>23.404255319148938</c:v>
                </c:pt>
                <c:pt idx="7">
                  <c:v>23.404255319148938</c:v>
                </c:pt>
                <c:pt idx="8">
                  <c:v>23.404255319148938</c:v>
                </c:pt>
                <c:pt idx="9">
                  <c:v>23.404255319148938</c:v>
                </c:pt>
                <c:pt idx="10">
                  <c:v>23.404255319148938</c:v>
                </c:pt>
                <c:pt idx="11">
                  <c:v>23.404255319148938</c:v>
                </c:pt>
                <c:pt idx="12">
                  <c:v>23.404255319148938</c:v>
                </c:pt>
                <c:pt idx="13">
                  <c:v>23.404255319148938</c:v>
                </c:pt>
                <c:pt idx="14">
                  <c:v>23.404255319148938</c:v>
                </c:pt>
                <c:pt idx="15">
                  <c:v>17.0212765957446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86A-B44C-AD87-9DB8363D8BFC}"/>
            </c:ext>
          </c:extLst>
        </c:ser>
        <c:ser>
          <c:idx val="4"/>
          <c:order val="4"/>
          <c:tx>
            <c:strRef>
              <c:f>'Fig. S4(D-Cysteine_derivatives)'!$B$92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rgbClr val="5D4703"/>
            </a:solidFill>
            <a:ln>
              <a:noFill/>
            </a:ln>
            <a:effectLst/>
          </c:spPr>
          <c:invertIfNegative val="0"/>
          <c:cat>
            <c:numRef>
              <c:f>'Fig. S4(D-Cysteine_derivatives)'!$C$87:$R$87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Fig. S4(D-Cysteine_derivatives)'!$C$92:$R$92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86A-B44C-AD87-9DB8363D8B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42544255"/>
        <c:axId val="674767055"/>
      </c:barChart>
      <c:catAx>
        <c:axId val="742544255"/>
        <c:scaling>
          <c:orientation val="minMax"/>
        </c:scaling>
        <c:delete val="0"/>
        <c:axPos val="b"/>
        <c:numFmt formatCode="0_);[Red]\(0\)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674767055"/>
        <c:crosses val="autoZero"/>
        <c:auto val="1"/>
        <c:lblAlgn val="ctr"/>
        <c:lblOffset val="100"/>
        <c:noMultiLvlLbl val="0"/>
      </c:catAx>
      <c:valAx>
        <c:axId val="674767055"/>
        <c:scaling>
          <c:orientation val="minMax"/>
        </c:scaling>
        <c:delete val="0"/>
        <c:axPos val="l"/>
        <c:numFmt formatCode="0_);[Red]\(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742544255"/>
        <c:crosses val="autoZero"/>
        <c:crossBetween val="between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7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9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Met [46]</a:t>
            </a:r>
            <a:endParaRPr lang="ja-JP" sz="9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40422852732701"/>
          <c:y val="0.32427093169812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2962726460017149"/>
          <c:y val="0.32057108824704961"/>
          <c:w val="0.81353935634046737"/>
          <c:h val="0.60034069640655308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死亡率と生存数の推移(L-メチオニン類縁体)'!$B$16</c:f>
              <c:strCache>
                <c:ptCount val="1"/>
                <c:pt idx="0">
                  <c:v>2n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死亡率と生存数の推移(L-メチオニ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メチオニン類縁体)'!$C$16:$R$16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EB-0A44-BACE-782D2140452B}"/>
            </c:ext>
          </c:extLst>
        </c:ser>
        <c:ser>
          <c:idx val="1"/>
          <c:order val="1"/>
          <c:tx>
            <c:strRef>
              <c:f>'死亡率と生存数の推移(L-メチオニン類縁体)'!$B$17</c:f>
              <c:strCache>
                <c:ptCount val="1"/>
                <c:pt idx="0">
                  <c:v>3rd</c:v>
                </c:pt>
              </c:strCache>
            </c:strRef>
          </c:tx>
          <c:spPr>
            <a:solidFill>
              <a:srgbClr val="4F9136"/>
            </a:solidFill>
            <a:ln>
              <a:noFill/>
            </a:ln>
            <a:effectLst/>
          </c:spPr>
          <c:invertIfNegative val="0"/>
          <c:cat>
            <c:numRef>
              <c:f>'死亡率と生存数の推移(L-メチオニ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メチオニン類縁体)'!$C$17:$R$17</c:f>
              <c:numCache>
                <c:formatCode>0_);[Red]\(0\)</c:formatCode>
                <c:ptCount val="16"/>
                <c:pt idx="0">
                  <c:v>100</c:v>
                </c:pt>
                <c:pt idx="1">
                  <c:v>100</c:v>
                </c:pt>
                <c:pt idx="2">
                  <c:v>26.086956521739129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EB-0A44-BACE-782D2140452B}"/>
            </c:ext>
          </c:extLst>
        </c:ser>
        <c:ser>
          <c:idx val="2"/>
          <c:order val="2"/>
          <c:tx>
            <c:strRef>
              <c:f>'死亡率と生存数の推移(L-メチオニン類縁体)'!$B$18</c:f>
              <c:strCache>
                <c:ptCount val="1"/>
                <c:pt idx="0">
                  <c:v>4th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numRef>
              <c:f>'死亡率と生存数の推移(L-メチオニ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メチオニン類縁体)'!$C$18:$R$18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71.739130434782609</c:v>
                </c:pt>
                <c:pt idx="3">
                  <c:v>97.826086956521735</c:v>
                </c:pt>
                <c:pt idx="4">
                  <c:v>97.826086956521735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1EB-0A44-BACE-782D2140452B}"/>
            </c:ext>
          </c:extLst>
        </c:ser>
        <c:ser>
          <c:idx val="3"/>
          <c:order val="3"/>
          <c:tx>
            <c:strRef>
              <c:f>'死亡率と生存数の推移(L-メチオニン類縁体)'!$B$19</c:f>
              <c:strCache>
                <c:ptCount val="1"/>
                <c:pt idx="0">
                  <c:v>5th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'死亡率と生存数の推移(L-メチオニ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メチオニン類縁体)'!$C$19:$R$19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1EB-0A44-BACE-782D2140452B}"/>
            </c:ext>
          </c:extLst>
        </c:ser>
        <c:ser>
          <c:idx val="4"/>
          <c:order val="4"/>
          <c:tx>
            <c:strRef>
              <c:f>'死亡率と生存数の推移(L-メチオニン類縁体)'!$B$20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numRef>
              <c:f>'死亡率と生存数の推移(L-メチオニン類縁体)'!$C$15:$R$15</c:f>
              <c:numCache>
                <c:formatCode>0_);[Red]\(0\)</c:formatCode>
                <c:ptCount val="1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</c:numCache>
            </c:numRef>
          </c:cat>
          <c:val>
            <c:numRef>
              <c:f>'死亡率と生存数の推移(L-メチオニン類縁体)'!$C$20:$R$20</c:f>
              <c:numCache>
                <c:formatCode>0_);[Red]\(0\)</c:formatCode>
                <c:ptCount val="1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1EB-0A44-BACE-782D214045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2843983"/>
        <c:axId val="182845983"/>
      </c:barChart>
      <c:catAx>
        <c:axId val="182843983"/>
        <c:scaling>
          <c:orientation val="minMax"/>
        </c:scaling>
        <c:delete val="0"/>
        <c:axPos val="b"/>
        <c:numFmt formatCode="0_);[Red]\(0\)" sourceLinked="1"/>
        <c:majorTickMark val="none"/>
        <c:minorTickMark val="none"/>
        <c:tickLblPos val="high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82845983"/>
        <c:crosses val="autoZero"/>
        <c:auto val="1"/>
        <c:lblAlgn val="ctr"/>
        <c:lblOffset val="100"/>
        <c:noMultiLvlLbl val="0"/>
      </c:catAx>
      <c:valAx>
        <c:axId val="182845983"/>
        <c:scaling>
          <c:orientation val="minMax"/>
          <c:max val="120"/>
        </c:scaling>
        <c:delete val="0"/>
        <c:axPos val="l"/>
        <c:numFmt formatCode="0_);[Red]\(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82843983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6EA505-B48D-C94B-A6FC-D17AA2AC95E4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5CB18D-D601-8240-A5D2-0C713B2143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174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0673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166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5424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7662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1140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951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3704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946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1862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016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310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321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92806E81-35D5-121F-ABD9-656E5A8F5599}"/>
              </a:ext>
            </a:extLst>
          </p:cNvPr>
          <p:cNvGrpSpPr/>
          <p:nvPr/>
        </p:nvGrpSpPr>
        <p:grpSpPr>
          <a:xfrm>
            <a:off x="344485" y="291857"/>
            <a:ext cx="3058473" cy="5514267"/>
            <a:chOff x="344485" y="896014"/>
            <a:chExt cx="3058473" cy="5514267"/>
          </a:xfrm>
        </p:grpSpPr>
        <p:graphicFrame>
          <p:nvGraphicFramePr>
            <p:cNvPr id="6" name="グラフ 5">
              <a:extLst>
                <a:ext uri="{FF2B5EF4-FFF2-40B4-BE49-F238E27FC236}">
                  <a16:creationId xmlns:a16="http://schemas.microsoft.com/office/drawing/2014/main" id="{12FC70CB-9E0B-4B33-147E-FD9B936F561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1637795"/>
                </p:ext>
              </p:extLst>
            </p:nvPr>
          </p:nvGraphicFramePr>
          <p:xfrm>
            <a:off x="482184" y="896014"/>
            <a:ext cx="2897032" cy="21446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1" name="グラフ 10">
              <a:extLst>
                <a:ext uri="{FF2B5EF4-FFF2-40B4-BE49-F238E27FC236}">
                  <a16:creationId xmlns:a16="http://schemas.microsoft.com/office/drawing/2014/main" id="{AE15787F-FB32-56A4-5AF9-B25BDD0EFDA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3973486"/>
                </p:ext>
              </p:extLst>
            </p:nvPr>
          </p:nvGraphicFramePr>
          <p:xfrm>
            <a:off x="493735" y="2321230"/>
            <a:ext cx="2897032" cy="172745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5" name="グラフ 14">
              <a:extLst>
                <a:ext uri="{FF2B5EF4-FFF2-40B4-BE49-F238E27FC236}">
                  <a16:creationId xmlns:a16="http://schemas.microsoft.com/office/drawing/2014/main" id="{D02649CD-6CB4-AA25-154B-6CF50CA13C0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62136290"/>
                </p:ext>
              </p:extLst>
            </p:nvPr>
          </p:nvGraphicFramePr>
          <p:xfrm>
            <a:off x="497335" y="3407594"/>
            <a:ext cx="2904983" cy="16687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7" name="三角形 16">
              <a:extLst>
                <a:ext uri="{FF2B5EF4-FFF2-40B4-BE49-F238E27FC236}">
                  <a16:creationId xmlns:a16="http://schemas.microsoft.com/office/drawing/2014/main" id="{3EF55756-4605-F7C0-3E40-72A25DC363B8}"/>
                </a:ext>
              </a:extLst>
            </p:cNvPr>
            <p:cNvSpPr/>
            <p:nvPr/>
          </p:nvSpPr>
          <p:spPr>
            <a:xfrm rot="10800000">
              <a:off x="2720429" y="2607652"/>
              <a:ext cx="45719" cy="81031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981B6832-472A-BF7C-9732-D4C50588BB4D}"/>
                </a:ext>
              </a:extLst>
            </p:cNvPr>
            <p:cNvSpPr txBox="1"/>
            <p:nvPr/>
          </p:nvSpPr>
          <p:spPr>
            <a:xfrm>
              <a:off x="1501496" y="1266801"/>
              <a:ext cx="11117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Days</a:t>
              </a:r>
              <a:endParaRPr kumimoji="1" lang="ja-JP" altLang="en-US" sz="80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1EE62676-5365-C067-85E5-D61644646040}"/>
                </a:ext>
              </a:extLst>
            </p:cNvPr>
            <p:cNvSpPr txBox="1"/>
            <p:nvPr/>
          </p:nvSpPr>
          <p:spPr>
            <a:xfrm>
              <a:off x="1476156" y="6194837"/>
              <a:ext cx="11117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Days</a:t>
              </a:r>
              <a:endParaRPr kumimoji="1" lang="ja-JP" altLang="en-US" sz="80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ECAFDCC8-3728-289D-00AE-A0C54CF8F60E}"/>
                </a:ext>
              </a:extLst>
            </p:cNvPr>
            <p:cNvSpPr txBox="1"/>
            <p:nvPr/>
          </p:nvSpPr>
          <p:spPr>
            <a:xfrm rot="16200000">
              <a:off x="-161822" y="3539670"/>
              <a:ext cx="12280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Survival rate (%)</a:t>
              </a:r>
              <a:endParaRPr kumimoji="1" lang="ja-JP" altLang="en-US" sz="80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21" name="三角形 20">
              <a:extLst>
                <a:ext uri="{FF2B5EF4-FFF2-40B4-BE49-F238E27FC236}">
                  <a16:creationId xmlns:a16="http://schemas.microsoft.com/office/drawing/2014/main" id="{0693E5B6-7BD9-2F93-4CEA-1448408C8C5C}"/>
                </a:ext>
              </a:extLst>
            </p:cNvPr>
            <p:cNvSpPr/>
            <p:nvPr/>
          </p:nvSpPr>
          <p:spPr>
            <a:xfrm rot="10800000">
              <a:off x="1690303" y="4799071"/>
              <a:ext cx="45719" cy="81031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三角形 21">
              <a:extLst>
                <a:ext uri="{FF2B5EF4-FFF2-40B4-BE49-F238E27FC236}">
                  <a16:creationId xmlns:a16="http://schemas.microsoft.com/office/drawing/2014/main" id="{A4A99A2C-4CDC-C935-AAA9-62CC50F012F7}"/>
                </a:ext>
              </a:extLst>
            </p:cNvPr>
            <p:cNvSpPr/>
            <p:nvPr/>
          </p:nvSpPr>
          <p:spPr>
            <a:xfrm rot="10800000">
              <a:off x="1821683" y="5885435"/>
              <a:ext cx="45719" cy="81031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4BBB20B0-B372-0D7D-4631-D6414ACCCAE6}"/>
                </a:ext>
              </a:extLst>
            </p:cNvPr>
            <p:cNvSpPr/>
            <p:nvPr/>
          </p:nvSpPr>
          <p:spPr>
            <a:xfrm>
              <a:off x="470633" y="1506922"/>
              <a:ext cx="282360" cy="2000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F7340057-D949-54E1-AA54-70EE1337EF0D}"/>
                </a:ext>
              </a:extLst>
            </p:cNvPr>
            <p:cNvSpPr txBox="1"/>
            <p:nvPr/>
          </p:nvSpPr>
          <p:spPr>
            <a:xfrm>
              <a:off x="493735" y="2656604"/>
              <a:ext cx="304838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8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0</a:t>
              </a:r>
              <a:endParaRPr kumimoji="1" lang="ja-JP" altLang="en-US" sz="80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1A7BFC21-8C5D-07DE-F561-F722A4D58F1A}"/>
                </a:ext>
              </a:extLst>
            </p:cNvPr>
            <p:cNvSpPr txBox="1"/>
            <p:nvPr/>
          </p:nvSpPr>
          <p:spPr>
            <a:xfrm>
              <a:off x="517364" y="3735711"/>
              <a:ext cx="304838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8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0</a:t>
              </a:r>
              <a:endParaRPr kumimoji="1" lang="ja-JP" altLang="en-US" sz="80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graphicFrame>
          <p:nvGraphicFramePr>
            <p:cNvPr id="16" name="グラフ 15">
              <a:extLst>
                <a:ext uri="{FF2B5EF4-FFF2-40B4-BE49-F238E27FC236}">
                  <a16:creationId xmlns:a16="http://schemas.microsoft.com/office/drawing/2014/main" id="{320A3341-724A-3D47-0B5C-E8B8253EE75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24966518"/>
                </p:ext>
              </p:extLst>
            </p:nvPr>
          </p:nvGraphicFramePr>
          <p:xfrm>
            <a:off x="494375" y="4509597"/>
            <a:ext cx="2908583" cy="183265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9ED58793-6223-196F-9F6B-C07F0C479A3B}"/>
                </a:ext>
              </a:extLst>
            </p:cNvPr>
            <p:cNvSpPr txBox="1"/>
            <p:nvPr/>
          </p:nvSpPr>
          <p:spPr>
            <a:xfrm>
              <a:off x="527090" y="4840894"/>
              <a:ext cx="304838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8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0</a:t>
              </a:r>
              <a:endParaRPr kumimoji="1" lang="ja-JP" altLang="en-US" sz="80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913B1EBC-FB8F-CF6F-0FE9-2A9507069C4E}"/>
              </a:ext>
            </a:extLst>
          </p:cNvPr>
          <p:cNvGrpSpPr/>
          <p:nvPr/>
        </p:nvGrpSpPr>
        <p:grpSpPr>
          <a:xfrm>
            <a:off x="205482" y="5880467"/>
            <a:ext cx="3223518" cy="1943045"/>
            <a:chOff x="271222" y="6641960"/>
            <a:chExt cx="3223518" cy="1943045"/>
          </a:xfrm>
        </p:grpSpPr>
        <p:graphicFrame>
          <p:nvGraphicFramePr>
            <p:cNvPr id="23" name="グラフ 22">
              <a:extLst>
                <a:ext uri="{FF2B5EF4-FFF2-40B4-BE49-F238E27FC236}">
                  <a16:creationId xmlns:a16="http://schemas.microsoft.com/office/drawing/2014/main" id="{EA8E235A-FF53-6F4E-BF18-C4E0D3F0D29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36263724"/>
                </p:ext>
              </p:extLst>
            </p:nvPr>
          </p:nvGraphicFramePr>
          <p:xfrm>
            <a:off x="271222" y="6641960"/>
            <a:ext cx="3223518" cy="183225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54467624-218C-5388-029F-C837B20EBF26}"/>
                </a:ext>
              </a:extLst>
            </p:cNvPr>
            <p:cNvSpPr txBox="1"/>
            <p:nvPr/>
          </p:nvSpPr>
          <p:spPr>
            <a:xfrm>
              <a:off x="1567236" y="8369561"/>
              <a:ext cx="11117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rPr>
                <a:t>Days</a:t>
              </a:r>
              <a:endParaRPr kumimoji="1" lang="ja-JP" altLang="en-US" sz="80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25" name="三角形 24">
              <a:extLst>
                <a:ext uri="{FF2B5EF4-FFF2-40B4-BE49-F238E27FC236}">
                  <a16:creationId xmlns:a16="http://schemas.microsoft.com/office/drawing/2014/main" id="{6EA85357-831E-5CD8-B606-5F3C98A8769F}"/>
                </a:ext>
              </a:extLst>
            </p:cNvPr>
            <p:cNvSpPr/>
            <p:nvPr/>
          </p:nvSpPr>
          <p:spPr>
            <a:xfrm rot="10800000">
              <a:off x="1880495" y="8071760"/>
              <a:ext cx="45719" cy="81031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45558EC8-5C75-5DB3-6B2F-6F388E341A8C}"/>
                </a:ext>
              </a:extLst>
            </p:cNvPr>
            <p:cNvSpPr/>
            <p:nvPr/>
          </p:nvSpPr>
          <p:spPr>
            <a:xfrm>
              <a:off x="606843" y="6893453"/>
              <a:ext cx="282360" cy="2000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3504A870-6B57-A590-3E96-FAAE3FA281E7}"/>
              </a:ext>
            </a:extLst>
          </p:cNvPr>
          <p:cNvSpPr txBox="1"/>
          <p:nvPr/>
        </p:nvSpPr>
        <p:spPr>
          <a:xfrm>
            <a:off x="616807" y="7947678"/>
            <a:ext cx="594723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4 Fig. </a:t>
            </a:r>
            <a:r>
              <a:rPr lang="en-US" altLang="ja-JP" sz="1000" b="1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Survival rates depend on the developmental stage of </a:t>
            </a:r>
            <a:r>
              <a:rPr lang="en-US" altLang="ja-JP" sz="1000" b="1" i="1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R. </a:t>
            </a:r>
            <a:r>
              <a:rPr lang="en-US" altLang="ja-JP" sz="1000" b="1" i="1" dirty="0" err="1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edestris</a:t>
            </a:r>
            <a:r>
              <a:rPr lang="en-US" altLang="ja-JP" sz="1000" b="1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.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Observations started from the 3</a:t>
            </a:r>
            <a:r>
              <a:rPr lang="en-US" altLang="ja-JP" sz="1000" kern="100" baseline="300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rd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instar nymphs. 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Color indicates developmental stage: green, 3</a:t>
            </a:r>
            <a:r>
              <a:rPr lang="en-US" altLang="ja-JP" sz="1000" baseline="300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rd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instar; blue, 4</a:t>
            </a:r>
            <a:r>
              <a:rPr lang="en-US" altLang="ja-JP" sz="1000" baseline="300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h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instar; yellow, 5</a:t>
            </a:r>
            <a:r>
              <a:rPr lang="en-US" altLang="ja-JP" sz="1000" baseline="300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h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instar; brown, adult.</a:t>
            </a:r>
            <a:r>
              <a:rPr lang="ja-JP" altLang="ja-JP" sz="3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Red Arrows indicate when all individuals died. </a:t>
            </a:r>
            <a:r>
              <a:rPr lang="en-US" altLang="ja-JP" sz="1000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The total numbers of insects at the starting time (day 0) are shown in brackets after the chemical names. 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Abbreviations: NAC, </a:t>
            </a:r>
            <a:r>
              <a:rPr lang="en-US" altLang="ja-JP" sz="1000" i="1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Acetyl-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ysteine;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</a:t>
            </a:r>
            <a:r>
              <a:rPr lang="en-US" altLang="ja-JP" sz="1000" kern="100" dirty="0" err="1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ys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,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ysteine;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ME,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ysteine methyl ester hydrochloride;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EE,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ysteine ethyl ester hydrochloride;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</a:t>
            </a:r>
            <a:r>
              <a:rPr lang="en-US" altLang="ja-JP" sz="1000" kern="100" dirty="0" err="1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ys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,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ysteine;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ME,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ysteine methyl ester hydrochloride; 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PA,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penicillamine; 2-AET, 2-amino ethanethiol;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Met,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methionine;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MME, </a:t>
            </a:r>
            <a:r>
              <a:rPr lang="en-US" altLang="ja-JP" sz="7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methionine methyl ester hydrochloride. </a:t>
            </a:r>
            <a:endParaRPr lang="en-US" altLang="ja-JP" sz="100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E495AB3E-67ED-D5F5-CC46-6F415699F09D}"/>
              </a:ext>
            </a:extLst>
          </p:cNvPr>
          <p:cNvGrpSpPr/>
          <p:nvPr/>
        </p:nvGrpSpPr>
        <p:grpSpPr>
          <a:xfrm>
            <a:off x="3450243" y="497689"/>
            <a:ext cx="3249137" cy="4242586"/>
            <a:chOff x="3450243" y="1101846"/>
            <a:chExt cx="3249137" cy="4242586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FB672065-78AA-6858-76A2-3DCB1FC6690E}"/>
                </a:ext>
              </a:extLst>
            </p:cNvPr>
            <p:cNvGrpSpPr/>
            <p:nvPr/>
          </p:nvGrpSpPr>
          <p:grpSpPr>
            <a:xfrm>
              <a:off x="3450243" y="1101846"/>
              <a:ext cx="3249137" cy="4242586"/>
              <a:chOff x="3450243" y="1101846"/>
              <a:chExt cx="3249137" cy="4242586"/>
            </a:xfrm>
          </p:grpSpPr>
          <p:grpSp>
            <p:nvGrpSpPr>
              <p:cNvPr id="45" name="グループ化 44">
                <a:extLst>
                  <a:ext uri="{FF2B5EF4-FFF2-40B4-BE49-F238E27FC236}">
                    <a16:creationId xmlns:a16="http://schemas.microsoft.com/office/drawing/2014/main" id="{140C554F-996F-3D08-14CA-71B29EA391F8}"/>
                  </a:ext>
                </a:extLst>
              </p:cNvPr>
              <p:cNvGrpSpPr/>
              <p:nvPr/>
            </p:nvGrpSpPr>
            <p:grpSpPr>
              <a:xfrm>
                <a:off x="3450243" y="1101846"/>
                <a:ext cx="3019312" cy="4144215"/>
                <a:chOff x="3450243" y="1101846"/>
                <a:chExt cx="3019312" cy="4144215"/>
              </a:xfrm>
            </p:grpSpPr>
            <p:graphicFrame>
              <p:nvGraphicFramePr>
                <p:cNvPr id="33" name="グラフ 32">
                  <a:extLst>
                    <a:ext uri="{FF2B5EF4-FFF2-40B4-BE49-F238E27FC236}">
                      <a16:creationId xmlns:a16="http://schemas.microsoft.com/office/drawing/2014/main" id="{5BC73E98-FB60-274F-A48B-E2E2F0A2EB11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73053942"/>
                    </p:ext>
                  </p:extLst>
                </p:nvPr>
              </p:nvGraphicFramePr>
              <p:xfrm>
                <a:off x="3590422" y="1101846"/>
                <a:ext cx="2879133" cy="177590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graphicFrame>
              <p:nvGraphicFramePr>
                <p:cNvPr id="34" name="グラフ 33">
                  <a:extLst>
                    <a:ext uri="{FF2B5EF4-FFF2-40B4-BE49-F238E27FC236}">
                      <a16:creationId xmlns:a16="http://schemas.microsoft.com/office/drawing/2014/main" id="{A28EA98E-3DFE-7545-9E85-8A141D73AD9E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54838797"/>
                    </p:ext>
                  </p:extLst>
                </p:nvPr>
              </p:nvGraphicFramePr>
              <p:xfrm>
                <a:off x="3590423" y="2366778"/>
                <a:ext cx="2879132" cy="155679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0C26FC91-90E9-CA29-0F42-A245F54C9A20}"/>
                    </a:ext>
                  </a:extLst>
                </p:cNvPr>
                <p:cNvSpPr txBox="1"/>
                <p:nvPr/>
              </p:nvSpPr>
              <p:spPr>
                <a:xfrm rot="16200000">
                  <a:off x="2951630" y="3069543"/>
                  <a:ext cx="1228057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900" dirty="0">
                      <a:latin typeface="Arial" panose="020B0604020202020204" pitchFamily="34" charset="0"/>
                      <a:ea typeface="Meiryo" panose="020B0604030504040204" pitchFamily="34" charset="-128"/>
                      <a:cs typeface="Arial" panose="020B0604020202020204" pitchFamily="34" charset="0"/>
                    </a:rPr>
                    <a:t>Survival rate (%)</a:t>
                  </a:r>
                  <a:endParaRPr kumimoji="1" lang="ja-JP" altLang="en-US" sz="90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FDBE8603-E105-E09D-FF85-1766B13448B4}"/>
                    </a:ext>
                  </a:extLst>
                </p:cNvPr>
                <p:cNvSpPr txBox="1"/>
                <p:nvPr/>
              </p:nvSpPr>
              <p:spPr>
                <a:xfrm>
                  <a:off x="4575722" y="1289775"/>
                  <a:ext cx="11117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ea typeface="Meiryo" panose="020B0604030504040204" pitchFamily="34" charset="-128"/>
                      <a:cs typeface="Arial" panose="020B0604020202020204" pitchFamily="34" charset="0"/>
                    </a:rPr>
                    <a:t>Days</a:t>
                  </a:r>
                  <a:endParaRPr kumimoji="1" lang="ja-JP" altLang="en-US" sz="80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CCB98489-923F-997F-918D-87ED0C22433F}"/>
                    </a:ext>
                  </a:extLst>
                </p:cNvPr>
                <p:cNvSpPr txBox="1"/>
                <p:nvPr/>
              </p:nvSpPr>
              <p:spPr>
                <a:xfrm>
                  <a:off x="4575722" y="5046006"/>
                  <a:ext cx="111173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Days</a:t>
                  </a:r>
                  <a:endParaRPr kumimoji="1" lang="ja-JP" altLang="en-US" sz="700"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  <p:sp>
              <p:nvSpPr>
                <p:cNvPr id="40" name="三角形 39">
                  <a:extLst>
                    <a:ext uri="{FF2B5EF4-FFF2-40B4-BE49-F238E27FC236}">
                      <a16:creationId xmlns:a16="http://schemas.microsoft.com/office/drawing/2014/main" id="{4DA5653E-DF61-9D86-2EC2-1570E366A4DE}"/>
                    </a:ext>
                  </a:extLst>
                </p:cNvPr>
                <p:cNvSpPr/>
                <p:nvPr/>
              </p:nvSpPr>
              <p:spPr>
                <a:xfrm rot="10800000">
                  <a:off x="4755146" y="3621223"/>
                  <a:ext cx="45719" cy="81031"/>
                </a:xfrm>
                <a:prstGeom prst="triangl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42" name="正方形/長方形 41">
                  <a:extLst>
                    <a:ext uri="{FF2B5EF4-FFF2-40B4-BE49-F238E27FC236}">
                      <a16:creationId xmlns:a16="http://schemas.microsoft.com/office/drawing/2014/main" id="{F223459A-5C90-36B8-AA0C-60CF7E0553D7}"/>
                    </a:ext>
                  </a:extLst>
                </p:cNvPr>
                <p:cNvSpPr/>
                <p:nvPr/>
              </p:nvSpPr>
              <p:spPr>
                <a:xfrm>
                  <a:off x="3583178" y="1522062"/>
                  <a:ext cx="282360" cy="20005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43" name="テキスト ボックス 42">
                  <a:extLst>
                    <a:ext uri="{FF2B5EF4-FFF2-40B4-BE49-F238E27FC236}">
                      <a16:creationId xmlns:a16="http://schemas.microsoft.com/office/drawing/2014/main" id="{E49A0035-A6C6-084D-CF84-F19A772EC30F}"/>
                    </a:ext>
                  </a:extLst>
                </p:cNvPr>
                <p:cNvSpPr txBox="1"/>
                <p:nvPr/>
              </p:nvSpPr>
              <p:spPr>
                <a:xfrm>
                  <a:off x="3615260" y="2616294"/>
                  <a:ext cx="304838" cy="21544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800" dirty="0">
                      <a:latin typeface="Arial" panose="020B0604020202020204" pitchFamily="34" charset="0"/>
                      <a:ea typeface="Meiryo" panose="020B0604030504040204" pitchFamily="34" charset="-128"/>
                      <a:cs typeface="Arial" panose="020B0604020202020204" pitchFamily="34" charset="0"/>
                    </a:rPr>
                    <a:t>0</a:t>
                  </a:r>
                  <a:endParaRPr kumimoji="1" lang="ja-JP" altLang="en-US" sz="80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テキスト ボックス 43">
                  <a:extLst>
                    <a:ext uri="{FF2B5EF4-FFF2-40B4-BE49-F238E27FC236}">
                      <a16:creationId xmlns:a16="http://schemas.microsoft.com/office/drawing/2014/main" id="{4CA59BF6-C73B-3D10-3111-7F1632324261}"/>
                    </a:ext>
                  </a:extLst>
                </p:cNvPr>
                <p:cNvSpPr txBox="1"/>
                <p:nvPr/>
              </p:nvSpPr>
              <p:spPr>
                <a:xfrm>
                  <a:off x="3621473" y="3694849"/>
                  <a:ext cx="304838" cy="20005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kumimoji="1" lang="en-US" altLang="ja-JP" sz="700" dirty="0">
                      <a:latin typeface="Meiryo" panose="020B0604030504040204" pitchFamily="34" charset="-128"/>
                      <a:ea typeface="Meiryo" panose="020B0604030504040204" pitchFamily="34" charset="-128"/>
                    </a:rPr>
                    <a:t>0</a:t>
                  </a:r>
                  <a:endParaRPr kumimoji="1" lang="ja-JP" altLang="en-US" sz="700">
                    <a:latin typeface="Meiryo" panose="020B0604030504040204" pitchFamily="34" charset="-128"/>
                    <a:ea typeface="Meiryo" panose="020B0604030504040204" pitchFamily="34" charset="-128"/>
                  </a:endParaRPr>
                </a:p>
              </p:txBody>
            </p:sp>
          </p:grpSp>
          <p:graphicFrame>
            <p:nvGraphicFramePr>
              <p:cNvPr id="2" name="グラフ 1">
                <a:extLst>
                  <a:ext uri="{FF2B5EF4-FFF2-40B4-BE49-F238E27FC236}">
                    <a16:creationId xmlns:a16="http://schemas.microsoft.com/office/drawing/2014/main" id="{B042C360-4C15-234C-B1F4-5E25402CF36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335865060"/>
                  </p:ext>
                </p:extLst>
              </p:nvPr>
            </p:nvGraphicFramePr>
            <p:xfrm>
              <a:off x="3452335" y="3351188"/>
              <a:ext cx="3247045" cy="199324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93C18A8C-2AF9-CC96-A19D-457D71DD8835}"/>
                  </a:ext>
                </a:extLst>
              </p:cNvPr>
              <p:cNvSpPr/>
              <p:nvPr/>
            </p:nvSpPr>
            <p:spPr>
              <a:xfrm>
                <a:off x="3579235" y="3694849"/>
                <a:ext cx="297186" cy="14936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80226F39-0398-50E1-6349-89F48492E0FB}"/>
                </a:ext>
              </a:extLst>
            </p:cNvPr>
            <p:cNvSpPr txBox="1"/>
            <p:nvPr/>
          </p:nvSpPr>
          <p:spPr>
            <a:xfrm>
              <a:off x="3623297" y="3677892"/>
              <a:ext cx="304838" cy="2000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700" dirty="0">
                  <a:latin typeface="Meiryo" panose="020B0604030504040204" pitchFamily="34" charset="-128"/>
                  <a:ea typeface="Meiryo" panose="020B0604030504040204" pitchFamily="34" charset="-128"/>
                </a:rPr>
                <a:t>0</a:t>
              </a:r>
              <a:endParaRPr kumimoji="1" lang="ja-JP" altLang="en-US" sz="700">
                <a:latin typeface="Meiryo" panose="020B0604030504040204" pitchFamily="34" charset="-128"/>
                <a:ea typeface="Meiryo" panose="020B0604030504040204" pitchFamily="34" charset="-128"/>
              </a:endParaRPr>
            </a:p>
          </p:txBody>
        </p:sp>
      </p:grp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0DDB1D8D-8B1A-AF24-898C-9741012197CB}"/>
              </a:ext>
            </a:extLst>
          </p:cNvPr>
          <p:cNvGrpSpPr/>
          <p:nvPr/>
        </p:nvGrpSpPr>
        <p:grpSpPr>
          <a:xfrm>
            <a:off x="3394624" y="4731005"/>
            <a:ext cx="3093487" cy="3128485"/>
            <a:chOff x="3394624" y="5377690"/>
            <a:chExt cx="3093487" cy="3128485"/>
          </a:xfrm>
        </p:grpSpPr>
        <p:grpSp>
          <p:nvGrpSpPr>
            <p:cNvPr id="57" name="グループ化 56">
              <a:extLst>
                <a:ext uri="{FF2B5EF4-FFF2-40B4-BE49-F238E27FC236}">
                  <a16:creationId xmlns:a16="http://schemas.microsoft.com/office/drawing/2014/main" id="{3EAE69EE-A74B-9FF9-E261-22FDCFE85CE8}"/>
                </a:ext>
              </a:extLst>
            </p:cNvPr>
            <p:cNvGrpSpPr/>
            <p:nvPr/>
          </p:nvGrpSpPr>
          <p:grpSpPr>
            <a:xfrm>
              <a:off x="3394624" y="5377690"/>
              <a:ext cx="3093487" cy="3128485"/>
              <a:chOff x="3394624" y="5377690"/>
              <a:chExt cx="3093487" cy="3128485"/>
            </a:xfrm>
          </p:grpSpPr>
          <p:grpSp>
            <p:nvGrpSpPr>
              <p:cNvPr id="8" name="グループ化 7">
                <a:extLst>
                  <a:ext uri="{FF2B5EF4-FFF2-40B4-BE49-F238E27FC236}">
                    <a16:creationId xmlns:a16="http://schemas.microsoft.com/office/drawing/2014/main" id="{56D8919D-4654-0CC7-24A7-FDB0F9132B1E}"/>
                  </a:ext>
                </a:extLst>
              </p:cNvPr>
              <p:cNvGrpSpPr/>
              <p:nvPr/>
            </p:nvGrpSpPr>
            <p:grpSpPr>
              <a:xfrm>
                <a:off x="3394624" y="5377690"/>
                <a:ext cx="3093487" cy="3128485"/>
                <a:chOff x="3394624" y="5377690"/>
                <a:chExt cx="3093487" cy="3128485"/>
              </a:xfrm>
            </p:grpSpPr>
            <p:grpSp>
              <p:nvGrpSpPr>
                <p:cNvPr id="55" name="グループ化 54">
                  <a:extLst>
                    <a:ext uri="{FF2B5EF4-FFF2-40B4-BE49-F238E27FC236}">
                      <a16:creationId xmlns:a16="http://schemas.microsoft.com/office/drawing/2014/main" id="{3CBFD384-43D8-E018-FFAB-9589C9030A1E}"/>
                    </a:ext>
                  </a:extLst>
                </p:cNvPr>
                <p:cNvGrpSpPr/>
                <p:nvPr/>
              </p:nvGrpSpPr>
              <p:grpSpPr>
                <a:xfrm>
                  <a:off x="3394624" y="5377690"/>
                  <a:ext cx="3093487" cy="3128485"/>
                  <a:chOff x="3394624" y="5377690"/>
                  <a:chExt cx="3093487" cy="3128485"/>
                </a:xfrm>
              </p:grpSpPr>
              <p:grpSp>
                <p:nvGrpSpPr>
                  <p:cNvPr id="53" name="グループ化 52">
                    <a:extLst>
                      <a:ext uri="{FF2B5EF4-FFF2-40B4-BE49-F238E27FC236}">
                        <a16:creationId xmlns:a16="http://schemas.microsoft.com/office/drawing/2014/main" id="{F0F4B3CF-9FA4-15AD-BA25-2CEB9A85BD67}"/>
                      </a:ext>
                    </a:extLst>
                  </p:cNvPr>
                  <p:cNvGrpSpPr/>
                  <p:nvPr/>
                </p:nvGrpSpPr>
                <p:grpSpPr>
                  <a:xfrm>
                    <a:off x="3394624" y="5377690"/>
                    <a:ext cx="3093487" cy="3128485"/>
                    <a:chOff x="3401918" y="5277662"/>
                    <a:chExt cx="3093487" cy="3128485"/>
                  </a:xfrm>
                </p:grpSpPr>
                <p:graphicFrame>
                  <p:nvGraphicFramePr>
                    <p:cNvPr id="46" name="グラフ 45">
                      <a:extLst>
                        <a:ext uri="{FF2B5EF4-FFF2-40B4-BE49-F238E27FC236}">
                          <a16:creationId xmlns:a16="http://schemas.microsoft.com/office/drawing/2014/main" id="{F3A38EBB-D60F-4948-B805-28AF4F834F0C}"/>
                        </a:ext>
                      </a:extLst>
                    </p:cNvPr>
                    <p:cNvGraphicFramePr>
                      <a:graphicFrameLocks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3916153905"/>
                        </p:ext>
                      </p:extLst>
                    </p:nvPr>
                  </p:nvGraphicFramePr>
                  <p:xfrm>
                    <a:off x="3590422" y="5277662"/>
                    <a:ext cx="2904983" cy="1771679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10"/>
                    </a:graphicData>
                  </a:graphic>
                </p:graphicFrame>
                <p:grpSp>
                  <p:nvGrpSpPr>
                    <p:cNvPr id="52" name="グループ化 51">
                      <a:extLst>
                        <a:ext uri="{FF2B5EF4-FFF2-40B4-BE49-F238E27FC236}">
                          <a16:creationId xmlns:a16="http://schemas.microsoft.com/office/drawing/2014/main" id="{3FC03517-981D-C00B-FF01-CEBFC8DE85B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401918" y="5475150"/>
                      <a:ext cx="2292832" cy="2930997"/>
                      <a:chOff x="3401918" y="5475150"/>
                      <a:chExt cx="2292832" cy="2930997"/>
                    </a:xfrm>
                  </p:grpSpPr>
                  <p:sp>
                    <p:nvSpPr>
                      <p:cNvPr id="9" name="テキスト ボックス 8">
                        <a:extLst>
                          <a:ext uri="{FF2B5EF4-FFF2-40B4-BE49-F238E27FC236}">
                            <a16:creationId xmlns:a16="http://schemas.microsoft.com/office/drawing/2014/main" id="{81AFD476-4FBB-7DBF-D534-F6645487EA0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583016" y="8190703"/>
                        <a:ext cx="1111734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800" dirty="0">
                            <a:latin typeface="Arial" panose="020B0604020202020204" pitchFamily="34" charset="0"/>
                            <a:ea typeface="Meiryo" panose="020B0604030504040204" pitchFamily="34" charset="-128"/>
                            <a:cs typeface="Arial" panose="020B0604020202020204" pitchFamily="34" charset="0"/>
                          </a:rPr>
                          <a:t>Days</a:t>
                        </a:r>
                        <a:endParaRPr kumimoji="1" lang="ja-JP" altLang="en-US" sz="80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48" name="三角形 47">
                        <a:extLst>
                          <a:ext uri="{FF2B5EF4-FFF2-40B4-BE49-F238E27FC236}">
                            <a16:creationId xmlns:a16="http://schemas.microsoft.com/office/drawing/2014/main" id="{02F24678-9855-EDD0-8C6D-AF79453ABAB3}"/>
                          </a:ext>
                        </a:extLst>
                      </p:cNvPr>
                      <p:cNvSpPr/>
                      <p:nvPr/>
                    </p:nvSpPr>
                    <p:spPr>
                      <a:xfrm rot="10800000">
                        <a:off x="4755145" y="6760261"/>
                        <a:ext cx="45719" cy="81031"/>
                      </a:xfrm>
                      <a:prstGeom prst="triangle">
                        <a:avLst/>
                      </a:prstGeom>
                      <a:solidFill>
                        <a:srgbClr val="FF0000"/>
                      </a:solidFill>
                      <a:ln>
                        <a:solidFill>
                          <a:srgbClr val="FF0000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/>
                      </a:p>
                    </p:txBody>
                  </p:sp>
                  <p:sp>
                    <p:nvSpPr>
                      <p:cNvPr id="49" name="テキスト ボックス 48">
                        <a:extLst>
                          <a:ext uri="{FF2B5EF4-FFF2-40B4-BE49-F238E27FC236}">
                            <a16:creationId xmlns:a16="http://schemas.microsoft.com/office/drawing/2014/main" id="{02D973C4-8290-A1B7-281A-1272FD5ACF27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2903305" y="6727428"/>
                        <a:ext cx="1228057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900" dirty="0">
                            <a:latin typeface="Arial" panose="020B0604020202020204" pitchFamily="34" charset="0"/>
                            <a:ea typeface="Meiryo" panose="020B0604030504040204" pitchFamily="34" charset="-128"/>
                            <a:cs typeface="Arial" panose="020B0604020202020204" pitchFamily="34" charset="0"/>
                          </a:rPr>
                          <a:t>Survival rate (%)</a:t>
                        </a:r>
                        <a:endParaRPr kumimoji="1" lang="ja-JP" altLang="en-US" sz="90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0" name="テキスト ボックス 49">
                        <a:extLst>
                          <a:ext uri="{FF2B5EF4-FFF2-40B4-BE49-F238E27FC236}">
                            <a16:creationId xmlns:a16="http://schemas.microsoft.com/office/drawing/2014/main" id="{24C87C02-0C10-FAAE-95D1-9453BAFF4F1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631709" y="6817348"/>
                        <a:ext cx="304838" cy="200055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bg1"/>
                        </a:solidFill>
                      </a:ln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kumimoji="1" lang="en-US" altLang="ja-JP" sz="700" dirty="0">
                            <a:latin typeface="Meiryo" panose="020B0604030504040204" pitchFamily="34" charset="-128"/>
                            <a:ea typeface="Meiryo" panose="020B0604030504040204" pitchFamily="34" charset="-128"/>
                          </a:rPr>
                          <a:t>0</a:t>
                        </a:r>
                        <a:endParaRPr kumimoji="1" lang="ja-JP" altLang="en-US" sz="700">
                          <a:latin typeface="Meiryo" panose="020B0604030504040204" pitchFamily="34" charset="-128"/>
                          <a:ea typeface="Meiryo" panose="020B0604030504040204" pitchFamily="34" charset="-128"/>
                        </a:endParaRPr>
                      </a:p>
                    </p:txBody>
                  </p:sp>
                  <p:sp>
                    <p:nvSpPr>
                      <p:cNvPr id="51" name="テキスト ボックス 50">
                        <a:extLst>
                          <a:ext uri="{FF2B5EF4-FFF2-40B4-BE49-F238E27FC236}">
                            <a16:creationId xmlns:a16="http://schemas.microsoft.com/office/drawing/2014/main" id="{1DDDB45F-4C6B-F619-4594-E7C2E06E05F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583016" y="5475150"/>
                        <a:ext cx="1111734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kumimoji="1" lang="en-US" altLang="ja-JP" sz="800" dirty="0">
                            <a:latin typeface="Arial" panose="020B0604020202020204" pitchFamily="34" charset="0"/>
                            <a:ea typeface="Meiryo" panose="020B0604030504040204" pitchFamily="34" charset="-128"/>
                            <a:cs typeface="Arial" panose="020B0604020202020204" pitchFamily="34" charset="0"/>
                          </a:rPr>
                          <a:t>Days</a:t>
                        </a:r>
                        <a:endParaRPr kumimoji="1" lang="ja-JP" altLang="en-US" sz="800">
                          <a:latin typeface="Arial" panose="020B0604020202020204" pitchFamily="34" charset="0"/>
                          <a:ea typeface="Meiryo" panose="020B0604030504040204" pitchFamily="34" charset="-128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  <p:sp>
                <p:nvSpPr>
                  <p:cNvPr id="54" name="正方形/長方形 53">
                    <a:extLst>
                      <a:ext uri="{FF2B5EF4-FFF2-40B4-BE49-F238E27FC236}">
                        <a16:creationId xmlns:a16="http://schemas.microsoft.com/office/drawing/2014/main" id="{DEB9A3C2-390D-15C6-C6D0-2385258E9C12}"/>
                      </a:ext>
                    </a:extLst>
                  </p:cNvPr>
                  <p:cNvSpPr/>
                  <p:nvPr/>
                </p:nvSpPr>
                <p:spPr>
                  <a:xfrm>
                    <a:off x="3594061" y="5808939"/>
                    <a:ext cx="282360" cy="20005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</p:grpSp>
            <p:graphicFrame>
              <p:nvGraphicFramePr>
                <p:cNvPr id="5" name="グラフ 4">
                  <a:extLst>
                    <a:ext uri="{FF2B5EF4-FFF2-40B4-BE49-F238E27FC236}">
                      <a16:creationId xmlns:a16="http://schemas.microsoft.com/office/drawing/2014/main" id="{71DEBC0D-719B-0A44-9C97-45239B1698D9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1956534"/>
                    </p:ext>
                  </p:extLst>
                </p:nvPr>
              </p:nvGraphicFramePr>
              <p:xfrm>
                <a:off x="3580831" y="6625331"/>
                <a:ext cx="2880000" cy="175824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1"/>
                </a:graphicData>
              </a:graphic>
            </p:graphicFrame>
            <p:sp>
              <p:nvSpPr>
                <p:cNvPr id="7" name="正方形/長方形 6">
                  <a:extLst>
                    <a:ext uri="{FF2B5EF4-FFF2-40B4-BE49-F238E27FC236}">
                      <a16:creationId xmlns:a16="http://schemas.microsoft.com/office/drawing/2014/main" id="{9257BFDB-5C17-0BA2-5130-78628C9A37BE}"/>
                    </a:ext>
                  </a:extLst>
                </p:cNvPr>
                <p:cNvSpPr/>
                <p:nvPr/>
              </p:nvSpPr>
              <p:spPr>
                <a:xfrm>
                  <a:off x="3624415" y="6936172"/>
                  <a:ext cx="252006" cy="181259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551AF04C-8F0E-B9FD-3F12-BD1FA500C729}"/>
                  </a:ext>
                </a:extLst>
              </p:cNvPr>
              <p:cNvSpPr txBox="1"/>
              <p:nvPr/>
            </p:nvSpPr>
            <p:spPr>
              <a:xfrm>
                <a:off x="3615260" y="6911137"/>
                <a:ext cx="304838" cy="21544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8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0</a:t>
                </a:r>
                <a:endParaRPr kumimoji="1" lang="ja-JP" altLang="en-US" sz="80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5" name="三角形 34">
              <a:extLst>
                <a:ext uri="{FF2B5EF4-FFF2-40B4-BE49-F238E27FC236}">
                  <a16:creationId xmlns:a16="http://schemas.microsoft.com/office/drawing/2014/main" id="{93069374-5AC5-79BB-6D38-2DD97B270E3E}"/>
                </a:ext>
              </a:extLst>
            </p:cNvPr>
            <p:cNvSpPr/>
            <p:nvPr/>
          </p:nvSpPr>
          <p:spPr>
            <a:xfrm rot="10800000">
              <a:off x="6219507" y="7942148"/>
              <a:ext cx="45719" cy="81031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549569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695</TotalTime>
  <Words>199</Words>
  <Application>Microsoft Office PowerPoint</Application>
  <PresentationFormat>A4 210 x 297 mm</PresentationFormat>
  <Paragraphs>3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</vt:lpstr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村洋行</dc:creator>
  <cp:lastModifiedBy>菊池義智</cp:lastModifiedBy>
  <cp:revision>246</cp:revision>
  <cp:lastPrinted>2023-04-03T02:46:52Z</cp:lastPrinted>
  <dcterms:created xsi:type="dcterms:W3CDTF">2023-03-01T02:57:03Z</dcterms:created>
  <dcterms:modified xsi:type="dcterms:W3CDTF">2024-10-07T13:40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dc55989-3c9e-4466-8514-eac6f80f6373_Enabled">
    <vt:lpwstr>true</vt:lpwstr>
  </property>
  <property fmtid="{D5CDD505-2E9C-101B-9397-08002B2CF9AE}" pid="3" name="MSIP_Label_ddc55989-3c9e-4466-8514-eac6f80f6373_SetDate">
    <vt:lpwstr>2023-05-01T09:10:28Z</vt:lpwstr>
  </property>
  <property fmtid="{D5CDD505-2E9C-101B-9397-08002B2CF9AE}" pid="4" name="MSIP_Label_ddc55989-3c9e-4466-8514-eac6f80f6373_Method">
    <vt:lpwstr>Privileged</vt:lpwstr>
  </property>
  <property fmtid="{D5CDD505-2E9C-101B-9397-08002B2CF9AE}" pid="5" name="MSIP_Label_ddc55989-3c9e-4466-8514-eac6f80f6373_Name">
    <vt:lpwstr>ddc55989-3c9e-4466-8514-eac6f80f6373</vt:lpwstr>
  </property>
  <property fmtid="{D5CDD505-2E9C-101B-9397-08002B2CF9AE}" pid="6" name="MSIP_Label_ddc55989-3c9e-4466-8514-eac6f80f6373_SiteId">
    <vt:lpwstr>18a7fec8-652f-409b-8369-272d9ce80620</vt:lpwstr>
  </property>
  <property fmtid="{D5CDD505-2E9C-101B-9397-08002B2CF9AE}" pid="7" name="MSIP_Label_ddc55989-3c9e-4466-8514-eac6f80f6373_ActionId">
    <vt:lpwstr>9c687925-788e-4260-a124-624eb367c218</vt:lpwstr>
  </property>
  <property fmtid="{D5CDD505-2E9C-101B-9397-08002B2CF9AE}" pid="8" name="MSIP_Label_ddc55989-3c9e-4466-8514-eac6f80f6373_ContentBits">
    <vt:lpwstr>0</vt:lpwstr>
  </property>
</Properties>
</file>